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120" y="2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C77B-EC67-438D-AE4B-E956DA0FA9A2}" type="datetimeFigureOut">
              <a:rPr lang="en-US" smtClean="0"/>
              <a:t>11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B7882-4263-4281-A72B-A20CFB117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73202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C77B-EC67-438D-AE4B-E956DA0FA9A2}" type="datetimeFigureOut">
              <a:rPr lang="en-US" smtClean="0"/>
              <a:t>11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B7882-4263-4281-A72B-A20CFB117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74475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C77B-EC67-438D-AE4B-E956DA0FA9A2}" type="datetimeFigureOut">
              <a:rPr lang="en-US" smtClean="0"/>
              <a:t>11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B7882-4263-4281-A72B-A20CFB117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45857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C77B-EC67-438D-AE4B-E956DA0FA9A2}" type="datetimeFigureOut">
              <a:rPr lang="en-US" smtClean="0"/>
              <a:t>11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B7882-4263-4281-A72B-A20CFB117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76759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C77B-EC67-438D-AE4B-E956DA0FA9A2}" type="datetimeFigureOut">
              <a:rPr lang="en-US" smtClean="0"/>
              <a:t>11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B7882-4263-4281-A72B-A20CFB117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7343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C77B-EC67-438D-AE4B-E956DA0FA9A2}" type="datetimeFigureOut">
              <a:rPr lang="en-US" smtClean="0"/>
              <a:t>11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B7882-4263-4281-A72B-A20CFB117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62985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C77B-EC67-438D-AE4B-E956DA0FA9A2}" type="datetimeFigureOut">
              <a:rPr lang="en-US" smtClean="0"/>
              <a:t>11/13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B7882-4263-4281-A72B-A20CFB117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66315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C77B-EC67-438D-AE4B-E956DA0FA9A2}" type="datetimeFigureOut">
              <a:rPr lang="en-US" smtClean="0"/>
              <a:t>11/13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B7882-4263-4281-A72B-A20CFB117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93393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C77B-EC67-438D-AE4B-E956DA0FA9A2}" type="datetimeFigureOut">
              <a:rPr lang="en-US" smtClean="0"/>
              <a:t>11/13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B7882-4263-4281-A72B-A20CFB117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31832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C77B-EC67-438D-AE4B-E956DA0FA9A2}" type="datetimeFigureOut">
              <a:rPr lang="en-US" smtClean="0"/>
              <a:t>11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B7882-4263-4281-A72B-A20CFB117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65334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C77B-EC67-438D-AE4B-E956DA0FA9A2}" type="datetimeFigureOut">
              <a:rPr lang="en-US" smtClean="0"/>
              <a:t>11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B7882-4263-4281-A72B-A20CFB117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89974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32C77B-EC67-438D-AE4B-E956DA0FA9A2}" type="datetimeFigureOut">
              <a:rPr lang="en-US" smtClean="0"/>
              <a:t>11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5B7882-4263-4281-A72B-A20CFB117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74432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45920" y="0"/>
            <a:ext cx="8062623" cy="5617918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2194560" y="5732095"/>
            <a:ext cx="775411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l Figure 3. Gating strategy for mitochondrial parameters and </a:t>
            </a:r>
            <a:r>
              <a:rPr lang="en-US" dirty="0" err="1" smtClean="0"/>
              <a:t>RedOx</a:t>
            </a:r>
            <a:r>
              <a:rPr lang="en-US" dirty="0" smtClean="0"/>
              <a:t> status in CD34+ MUTZ3 cells</a:t>
            </a:r>
            <a:r>
              <a:rPr lang="en-US" dirty="0" smtClean="0"/>
              <a:t>.  GSH = glutathione, FSC = forward scatter, SSC = </a:t>
            </a:r>
            <a:r>
              <a:rPr lang="en-US" smtClean="0"/>
              <a:t>Side Scatter.</a:t>
            </a:r>
            <a:endParaRPr lang="en-US" dirty="0"/>
          </a:p>
        </p:txBody>
      </p:sp>
      <p:sp>
        <p:nvSpPr>
          <p:cNvPr id="7" name="Right Arrow 6"/>
          <p:cNvSpPr/>
          <p:nvPr/>
        </p:nvSpPr>
        <p:spPr>
          <a:xfrm>
            <a:off x="4306824" y="1545336"/>
            <a:ext cx="457200" cy="246888"/>
          </a:xfrm>
          <a:prstGeom prst="rightArrow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ight Arrow 8"/>
          <p:cNvSpPr/>
          <p:nvPr/>
        </p:nvSpPr>
        <p:spPr>
          <a:xfrm>
            <a:off x="6967728" y="1545336"/>
            <a:ext cx="457200" cy="246888"/>
          </a:xfrm>
          <a:prstGeom prst="rightArrow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/>
          <p:cNvSpPr txBox="1"/>
          <p:nvPr/>
        </p:nvSpPr>
        <p:spPr>
          <a:xfrm>
            <a:off x="3200399" y="1391447"/>
            <a:ext cx="8046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76.6%</a:t>
            </a:r>
            <a:endParaRPr lang="en-US" sz="12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5084063" y="1101957"/>
            <a:ext cx="6766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94.8%</a:t>
            </a:r>
            <a:endParaRPr lang="en-US" sz="12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8400287" y="1231312"/>
            <a:ext cx="6766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54.3%</a:t>
            </a:r>
            <a:endParaRPr lang="en-US" sz="12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3375990" y="3907456"/>
            <a:ext cx="6766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94.5%</a:t>
            </a:r>
            <a:endParaRPr lang="en-US" sz="12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6071616" y="3907456"/>
            <a:ext cx="6766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91.6%</a:t>
            </a:r>
            <a:endParaRPr lang="en-US" sz="12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8738615" y="3907455"/>
            <a:ext cx="6766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95.3%</a:t>
            </a:r>
            <a:endParaRPr lang="en-US" sz="1200" b="1" dirty="0"/>
          </a:p>
        </p:txBody>
      </p:sp>
      <p:pic>
        <p:nvPicPr>
          <p:cNvPr id="20" name="Picture 19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338" t="50186" r="66392" b="43955"/>
          <a:stretch/>
        </p:blipFill>
        <p:spPr>
          <a:xfrm>
            <a:off x="5084063" y="2819854"/>
            <a:ext cx="1956817" cy="329184"/>
          </a:xfrm>
          <a:prstGeom prst="rect">
            <a:avLst/>
          </a:prstGeom>
        </p:spPr>
      </p:pic>
      <p:pic>
        <p:nvPicPr>
          <p:cNvPr id="21" name="Picture 20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338" t="50186" r="66392" b="43955"/>
          <a:stretch/>
        </p:blipFill>
        <p:spPr>
          <a:xfrm>
            <a:off x="7760206" y="2819854"/>
            <a:ext cx="1956817" cy="3291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966336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44</Words>
  <Application>Microsoft Office PowerPoint</Application>
  <PresentationFormat>Widescreen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cTernan, Patrick</dc:creator>
  <cp:lastModifiedBy>McTernan, Patrick</cp:lastModifiedBy>
  <cp:revision>13</cp:revision>
  <dcterms:created xsi:type="dcterms:W3CDTF">2020-05-21T15:38:18Z</dcterms:created>
  <dcterms:modified xsi:type="dcterms:W3CDTF">2020-11-13T22:44:36Z</dcterms:modified>
</cp:coreProperties>
</file>